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57" r:id="rId5"/>
    <p:sldId id="25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38"/>
    <p:restoredTop sz="95814"/>
  </p:normalViewPr>
  <p:slideViewPr>
    <p:cSldViewPr snapToGrid="0" snapToObjects="1">
      <p:cViewPr varScale="1">
        <p:scale>
          <a:sx n="117" d="100"/>
          <a:sy n="117" d="100"/>
        </p:scale>
        <p:origin x="114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9C20F9-C9B6-5A43-86C8-0A48E2632DB8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073606-DCFF-404E-877F-57F8929F6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481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DCDA5E-15B5-7245-B8DC-869D00AB55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44A6B1-3FBD-D943-A54B-32FC1EDDF2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646437-FC6C-854D-A2E3-5DF64CFED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59E71-8C87-9740-95DB-6DB1E0EA9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5D8FD-8883-F84D-93E8-7841B914D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135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387E3-3444-6A45-9575-2129761189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3F446C-EBB1-5E41-8909-077D8ABF9F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8FCD5-51B2-6B45-B98F-972D3C8BA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B88DD-FD72-4243-8D4E-1A5C90126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FFCC0E-EEDD-B849-9C45-237A8A1A4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60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F70C77-CCBA-8842-9A98-1D08E15178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8EAD94-31F0-AD49-8BDD-944D6FF055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43E0F0-3C93-C443-95A6-1E56950A1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3E246C-FD6B-0446-8EA4-0A0A85ED1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1A55DC-CB86-5747-9578-264A03547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582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2A8567-98EE-FE41-8E33-C3C6AC4FD0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D2E1E9-BCE0-A247-883B-2A2449E134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7AF52-8B2E-714B-9668-D79F4D7B9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59F6C-476C-AB42-B686-D5DFEC37B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6FBC3C-9DF3-C746-9ACC-E94880A5A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918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D6ED96-DDCF-A44C-9A13-764F3C91A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CE7918-06ED-DE43-9EDB-B2E4BCEF28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07906F-A208-CA4E-8BE9-9214A0D9B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B2C0DD-BA6C-7E44-86B9-E402A5A44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89E230-403C-0B46-82CA-E1839CBAA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082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1C42C5-7D42-9648-BD17-E3C79D034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7FAC5F-DEE4-2D4A-AB60-F252A71DE5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65B31D-B425-AE46-8038-6EC83BCBFA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A7342A-75DD-6B42-AAD4-D9A06BC18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A6A477-43BD-AF4A-B8B1-00ECAA50C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B04ECA-FFCC-D544-8999-16A98DE0E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587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C723D-74E1-4B43-A766-0B5A3C985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53622E-F525-494A-A3E9-B3F603FE28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A9A637-4C21-1946-A5F6-B54244E1C6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DD0314-E8CD-1D46-AD42-AEDE9A6D0A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CA07B03-E856-BA4A-B159-B06E8F60AB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DF868C-1739-3246-A23B-ECEE749AB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3FB2D2-DBCE-004E-8A80-37985E043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45EAE7E-C9EE-114A-9648-BB60850C6E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95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6E5BB-9144-EF44-AC2D-7CD6D6C1BD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312A97-3759-ED4B-9DE1-2364A32A0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A97769-6D9C-5D47-A901-595501F75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0B3F5F2-DD76-1045-A057-D3ABE0C4D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566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361929-8543-824E-9C23-6DDDF94FD5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0901BE-3D9C-7F42-A7AD-DC446F257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E5767D-7342-E149-8726-703B874F7A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039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69DB6-AEE3-1C44-96E6-A4EE7CC02D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A4C3EE-471A-1E49-85B3-1A3BDC00DC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CC0B0A-BB61-1747-BDE4-F8F4B18577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48D8D0-408C-B74D-A25E-4BE2A7871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DDBCD2-39F1-DF40-B741-BF459894F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9DCE9-62A3-A24A-B95A-F3C513396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301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DA25E-A03C-7B4C-8C5D-F0B34B233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19318CD-22C0-D147-A501-E52CA48D56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D3D30E-24D5-2C4D-A8C1-6930A4BFEE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EC3FE0-C0B6-D74D-93F9-C02635870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91DB57-917F-0A44-9046-5386D7590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B3F897-59DE-8942-B4EA-74C001E3A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157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8E7109-3D7B-1147-98FF-297E08377B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1BB037-6C76-744A-87A5-98722C7A03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D2044E-2EA8-0D4C-9E58-E1A3E32077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ABC49-8DCC-7B47-99C0-49B05DBACF8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EE5ACB-58DA-2449-A722-31E2652E8B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DE2ADE-FF99-A94B-8AAC-BE6BE29A89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802DF-E052-C74A-9978-0A528F3FBC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113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C329932-6ECB-EE4F-96B8-7010B21180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3671" y="1488622"/>
            <a:ext cx="6680200" cy="52451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D21BD49-3E73-CE41-9B7F-3D88E60880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5240229"/>
              </p:ext>
            </p:extLst>
          </p:nvPr>
        </p:nvGraphicFramePr>
        <p:xfrm>
          <a:off x="2283099" y="783986"/>
          <a:ext cx="7197049" cy="757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34272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48343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48343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77372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61583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06074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36285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48343">
                  <a:extLst>
                    <a:ext uri="{9D8B030D-6E8A-4147-A177-3AD203B41FA5}">
                      <a16:colId xmlns:a16="http://schemas.microsoft.com/office/drawing/2014/main" val="1122288902"/>
                    </a:ext>
                  </a:extLst>
                </a:gridCol>
                <a:gridCol w="377371">
                  <a:extLst>
                    <a:ext uri="{9D8B030D-6E8A-4147-A177-3AD203B41FA5}">
                      <a16:colId xmlns:a16="http://schemas.microsoft.com/office/drawing/2014/main" val="1675036579"/>
                    </a:ext>
                  </a:extLst>
                </a:gridCol>
                <a:gridCol w="362857">
                  <a:extLst>
                    <a:ext uri="{9D8B030D-6E8A-4147-A177-3AD203B41FA5}">
                      <a16:colId xmlns:a16="http://schemas.microsoft.com/office/drawing/2014/main" val="1232579594"/>
                    </a:ext>
                  </a:extLst>
                </a:gridCol>
                <a:gridCol w="275772">
                  <a:extLst>
                    <a:ext uri="{9D8B030D-6E8A-4147-A177-3AD203B41FA5}">
                      <a16:colId xmlns:a16="http://schemas.microsoft.com/office/drawing/2014/main" val="2052901313"/>
                    </a:ext>
                  </a:extLst>
                </a:gridCol>
                <a:gridCol w="391885">
                  <a:extLst>
                    <a:ext uri="{9D8B030D-6E8A-4147-A177-3AD203B41FA5}">
                      <a16:colId xmlns:a16="http://schemas.microsoft.com/office/drawing/2014/main" val="2884218403"/>
                    </a:ext>
                  </a:extLst>
                </a:gridCol>
                <a:gridCol w="333829">
                  <a:extLst>
                    <a:ext uri="{9D8B030D-6E8A-4147-A177-3AD203B41FA5}">
                      <a16:colId xmlns:a16="http://schemas.microsoft.com/office/drawing/2014/main" val="1594258366"/>
                    </a:ext>
                  </a:extLst>
                </a:gridCol>
                <a:gridCol w="348343">
                  <a:extLst>
                    <a:ext uri="{9D8B030D-6E8A-4147-A177-3AD203B41FA5}">
                      <a16:colId xmlns:a16="http://schemas.microsoft.com/office/drawing/2014/main" val="4172980973"/>
                    </a:ext>
                  </a:extLst>
                </a:gridCol>
                <a:gridCol w="377371">
                  <a:extLst>
                    <a:ext uri="{9D8B030D-6E8A-4147-A177-3AD203B41FA5}">
                      <a16:colId xmlns:a16="http://schemas.microsoft.com/office/drawing/2014/main" val="4043785966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val="668396626"/>
                    </a:ext>
                  </a:extLst>
                </a:gridCol>
                <a:gridCol w="348343">
                  <a:extLst>
                    <a:ext uri="{9D8B030D-6E8A-4147-A177-3AD203B41FA5}">
                      <a16:colId xmlns:a16="http://schemas.microsoft.com/office/drawing/2014/main" val="4287412152"/>
                    </a:ext>
                  </a:extLst>
                </a:gridCol>
                <a:gridCol w="493486">
                  <a:extLst>
                    <a:ext uri="{9D8B030D-6E8A-4147-A177-3AD203B41FA5}">
                      <a16:colId xmlns:a16="http://schemas.microsoft.com/office/drawing/2014/main" val="3165273348"/>
                    </a:ext>
                  </a:extLst>
                </a:gridCol>
                <a:gridCol w="495805">
                  <a:extLst>
                    <a:ext uri="{9D8B030D-6E8A-4147-A177-3AD203B41FA5}">
                      <a16:colId xmlns:a16="http://schemas.microsoft.com/office/drawing/2014/main" val="2981933755"/>
                    </a:ext>
                  </a:extLst>
                </a:gridCol>
              </a:tblGrid>
              <a:tr h="378620">
                <a:tc>
                  <a:txBody>
                    <a:bodyPr/>
                    <a:lstStyle/>
                    <a:p>
                      <a:r>
                        <a:rPr lang="en-US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78620">
                <a:tc>
                  <a:txBody>
                    <a:bodyPr/>
                    <a:lstStyle/>
                    <a:p>
                      <a:r>
                        <a:rPr lang="en-US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1726722" y="3926506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FLA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B42004-C67C-C840-A219-B4F422F43A9C}"/>
              </a:ext>
            </a:extLst>
          </p:cNvPr>
          <p:cNvSpPr txBox="1"/>
          <p:nvPr/>
        </p:nvSpPr>
        <p:spPr>
          <a:xfrm>
            <a:off x="9457288" y="316781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D3141E86-C930-AE46-A713-CC4BFBA577D1}"/>
              </a:ext>
            </a:extLst>
          </p:cNvPr>
          <p:cNvCxnSpPr>
            <a:cxnSpLocks/>
          </p:cNvCxnSpPr>
          <p:nvPr/>
        </p:nvCxnSpPr>
        <p:spPr>
          <a:xfrm flipH="1">
            <a:off x="9240244" y="57331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CD9E6525-85D4-D541-AC9C-2A2F432D81B8}"/>
              </a:ext>
            </a:extLst>
          </p:cNvPr>
          <p:cNvCxnSpPr>
            <a:cxnSpLocks/>
          </p:cNvCxnSpPr>
          <p:nvPr/>
        </p:nvCxnSpPr>
        <p:spPr>
          <a:xfrm flipH="1">
            <a:off x="9242704" y="335539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7CDE00D6-D7A9-254B-8298-745DE4D7452A}"/>
              </a:ext>
            </a:extLst>
          </p:cNvPr>
          <p:cNvSpPr/>
          <p:nvPr/>
        </p:nvSpPr>
        <p:spPr>
          <a:xfrm>
            <a:off x="9422998" y="5547005"/>
            <a:ext cx="16669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 smtClean="0"/>
              <a:t>cytTM-SpoIVFB</a:t>
            </a:r>
            <a:endParaRPr lang="en-US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B619E46D-809C-6E4E-8E60-65F3C12E9AD1}"/>
              </a:ext>
            </a:extLst>
          </p:cNvPr>
          <p:cNvCxnSpPr>
            <a:cxnSpLocks/>
          </p:cNvCxnSpPr>
          <p:nvPr/>
        </p:nvCxnSpPr>
        <p:spPr>
          <a:xfrm flipH="1">
            <a:off x="9240244" y="383598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0A46611C-C916-DC48-A8CE-74DAB40B2D80}"/>
              </a:ext>
            </a:extLst>
          </p:cNvPr>
          <p:cNvSpPr/>
          <p:nvPr/>
        </p:nvSpPr>
        <p:spPr>
          <a:xfrm>
            <a:off x="9422998" y="3649866"/>
            <a:ext cx="166699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cytTM-SpoIVFB</a:t>
            </a:r>
            <a:endParaRPr lang="en-US" dirty="0"/>
          </a:p>
          <a:p>
            <a:r>
              <a:rPr lang="en-US" dirty="0"/>
              <a:t>dimer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F4C5E81-9160-5346-977B-75A0F73417B3}"/>
              </a:ext>
            </a:extLst>
          </p:cNvPr>
          <p:cNvCxnSpPr>
            <a:cxnSpLocks/>
          </p:cNvCxnSpPr>
          <p:nvPr/>
        </p:nvCxnSpPr>
        <p:spPr>
          <a:xfrm>
            <a:off x="3584784" y="8802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796244DE-BC89-5B47-A741-75E0A0812D53}"/>
              </a:ext>
            </a:extLst>
          </p:cNvPr>
          <p:cNvCxnSpPr>
            <a:cxnSpLocks/>
          </p:cNvCxnSpPr>
          <p:nvPr/>
        </p:nvCxnSpPr>
        <p:spPr>
          <a:xfrm>
            <a:off x="4658842" y="8802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D18DDFA-0E09-9246-84C2-A28E3CA607B6}"/>
              </a:ext>
            </a:extLst>
          </p:cNvPr>
          <p:cNvCxnSpPr>
            <a:cxnSpLocks/>
          </p:cNvCxnSpPr>
          <p:nvPr/>
        </p:nvCxnSpPr>
        <p:spPr>
          <a:xfrm>
            <a:off x="5703870" y="88026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AC1922A-B7C5-FC47-8D1F-A18810797EFD}"/>
              </a:ext>
            </a:extLst>
          </p:cNvPr>
          <p:cNvCxnSpPr>
            <a:cxnSpLocks/>
          </p:cNvCxnSpPr>
          <p:nvPr/>
        </p:nvCxnSpPr>
        <p:spPr>
          <a:xfrm>
            <a:off x="6734384" y="96702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3193744-1D90-5B4C-AB3F-6DC6DB9E26D9}"/>
              </a:ext>
            </a:extLst>
          </p:cNvPr>
          <p:cNvCxnSpPr>
            <a:cxnSpLocks/>
          </p:cNvCxnSpPr>
          <p:nvPr/>
        </p:nvCxnSpPr>
        <p:spPr>
          <a:xfrm>
            <a:off x="7779413" y="96702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636C324-5638-9146-B0A9-BB0622C35969}"/>
              </a:ext>
            </a:extLst>
          </p:cNvPr>
          <p:cNvSpPr txBox="1"/>
          <p:nvPr/>
        </p:nvSpPr>
        <p:spPr>
          <a:xfrm>
            <a:off x="2807007" y="128979"/>
            <a:ext cx="7777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P135C</a:t>
            </a:r>
          </a:p>
          <a:p>
            <a:pPr algn="ctr"/>
            <a:r>
              <a:rPr lang="en-US" dirty="0"/>
              <a:t>C4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BE6D543-0948-194F-BD65-A9724E82D599}"/>
              </a:ext>
            </a:extLst>
          </p:cNvPr>
          <p:cNvSpPr txBox="1"/>
          <p:nvPr/>
        </p:nvSpPr>
        <p:spPr>
          <a:xfrm>
            <a:off x="3784219" y="128978"/>
            <a:ext cx="6751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A32C</a:t>
            </a:r>
          </a:p>
          <a:p>
            <a:pPr algn="ctr"/>
            <a:r>
              <a:rPr lang="en-US" dirty="0"/>
              <a:t>I56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A4A1F7-1701-3B4E-8E0C-6B64E7520CEB}"/>
              </a:ext>
            </a:extLst>
          </p:cNvPr>
          <p:cNvSpPr txBox="1"/>
          <p:nvPr/>
        </p:nvSpPr>
        <p:spPr>
          <a:xfrm>
            <a:off x="4859880" y="137655"/>
            <a:ext cx="673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86C</a:t>
            </a:r>
          </a:p>
          <a:p>
            <a:pPr algn="ctr"/>
            <a:r>
              <a:rPr lang="en-US" dirty="0"/>
              <a:t>A41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2E82AB-0883-EA41-A2E4-92C73C86B22C}"/>
              </a:ext>
            </a:extLst>
          </p:cNvPr>
          <p:cNvSpPr txBox="1"/>
          <p:nvPr/>
        </p:nvSpPr>
        <p:spPr>
          <a:xfrm>
            <a:off x="5899168" y="137655"/>
            <a:ext cx="6399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L33C</a:t>
            </a:r>
          </a:p>
          <a:p>
            <a:pPr algn="ctr"/>
            <a:r>
              <a:rPr lang="en-US" dirty="0"/>
              <a:t>I56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E57BF36-0C26-9F44-83D4-AD5AB751CF38}"/>
              </a:ext>
            </a:extLst>
          </p:cNvPr>
          <p:cNvSpPr txBox="1"/>
          <p:nvPr/>
        </p:nvSpPr>
        <p:spPr>
          <a:xfrm>
            <a:off x="6843992" y="137655"/>
            <a:ext cx="8146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Q181C</a:t>
            </a:r>
          </a:p>
          <a:p>
            <a:pPr algn="ctr"/>
            <a:r>
              <a:rPr lang="en-US" dirty="0"/>
              <a:t>H57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1B3E14-6901-684D-A655-D7C928EC3839}"/>
              </a:ext>
            </a:extLst>
          </p:cNvPr>
          <p:cNvSpPr txBox="1"/>
          <p:nvPr/>
        </p:nvSpPr>
        <p:spPr>
          <a:xfrm>
            <a:off x="7982109" y="128977"/>
            <a:ext cx="6880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86C</a:t>
            </a:r>
          </a:p>
          <a:p>
            <a:pPr algn="ctr"/>
            <a:r>
              <a:rPr lang="en-US" dirty="0"/>
              <a:t>G40C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1761155" y="4193205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lot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4057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25B885B-8DBC-954C-87C8-59AFA95E0E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4240" y="1803400"/>
            <a:ext cx="5257800" cy="48514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524B5F5-A3BC-DC44-891D-0034E19B0F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886866"/>
              </p:ext>
            </p:extLst>
          </p:nvPr>
        </p:nvGraphicFramePr>
        <p:xfrm>
          <a:off x="3444240" y="1046160"/>
          <a:ext cx="8354177" cy="757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77994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7970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44378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0861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7190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08610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00050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31470">
                  <a:extLst>
                    <a:ext uri="{9D8B030D-6E8A-4147-A177-3AD203B41FA5}">
                      <a16:colId xmlns:a16="http://schemas.microsoft.com/office/drawing/2014/main" val="1122288902"/>
                    </a:ext>
                  </a:extLst>
                </a:gridCol>
                <a:gridCol w="320040">
                  <a:extLst>
                    <a:ext uri="{9D8B030D-6E8A-4147-A177-3AD203B41FA5}">
                      <a16:colId xmlns:a16="http://schemas.microsoft.com/office/drawing/2014/main" val="1675036579"/>
                    </a:ext>
                  </a:extLst>
                </a:gridCol>
                <a:gridCol w="1191823">
                  <a:extLst>
                    <a:ext uri="{9D8B030D-6E8A-4147-A177-3AD203B41FA5}">
                      <a16:colId xmlns:a16="http://schemas.microsoft.com/office/drawing/2014/main" val="1232579594"/>
                    </a:ext>
                  </a:extLst>
                </a:gridCol>
                <a:gridCol w="362148">
                  <a:extLst>
                    <a:ext uri="{9D8B030D-6E8A-4147-A177-3AD203B41FA5}">
                      <a16:colId xmlns:a16="http://schemas.microsoft.com/office/drawing/2014/main" val="2052901313"/>
                    </a:ext>
                  </a:extLst>
                </a:gridCol>
                <a:gridCol w="402956">
                  <a:extLst>
                    <a:ext uri="{9D8B030D-6E8A-4147-A177-3AD203B41FA5}">
                      <a16:colId xmlns:a16="http://schemas.microsoft.com/office/drawing/2014/main" val="2884218403"/>
                    </a:ext>
                  </a:extLst>
                </a:gridCol>
                <a:gridCol w="426203">
                  <a:extLst>
                    <a:ext uri="{9D8B030D-6E8A-4147-A177-3AD203B41FA5}">
                      <a16:colId xmlns:a16="http://schemas.microsoft.com/office/drawing/2014/main" val="1594258366"/>
                    </a:ext>
                  </a:extLst>
                </a:gridCol>
                <a:gridCol w="395207">
                  <a:extLst>
                    <a:ext uri="{9D8B030D-6E8A-4147-A177-3AD203B41FA5}">
                      <a16:colId xmlns:a16="http://schemas.microsoft.com/office/drawing/2014/main" val="4172980973"/>
                    </a:ext>
                  </a:extLst>
                </a:gridCol>
                <a:gridCol w="426203">
                  <a:extLst>
                    <a:ext uri="{9D8B030D-6E8A-4147-A177-3AD203B41FA5}">
                      <a16:colId xmlns:a16="http://schemas.microsoft.com/office/drawing/2014/main" val="4043785966"/>
                    </a:ext>
                  </a:extLst>
                </a:gridCol>
                <a:gridCol w="433953">
                  <a:extLst>
                    <a:ext uri="{9D8B030D-6E8A-4147-A177-3AD203B41FA5}">
                      <a16:colId xmlns:a16="http://schemas.microsoft.com/office/drawing/2014/main" val="668396626"/>
                    </a:ext>
                  </a:extLst>
                </a:gridCol>
                <a:gridCol w="410830">
                  <a:extLst>
                    <a:ext uri="{9D8B030D-6E8A-4147-A177-3AD203B41FA5}">
                      <a16:colId xmlns:a16="http://schemas.microsoft.com/office/drawing/2014/main" val="4287412152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3165273348"/>
                    </a:ext>
                  </a:extLst>
                </a:gridCol>
                <a:gridCol w="445324">
                  <a:extLst>
                    <a:ext uri="{9D8B030D-6E8A-4147-A177-3AD203B41FA5}">
                      <a16:colId xmlns:a16="http://schemas.microsoft.com/office/drawing/2014/main" val="2981933755"/>
                    </a:ext>
                  </a:extLst>
                </a:gridCol>
              </a:tblGrid>
              <a:tr h="378620">
                <a:tc>
                  <a:txBody>
                    <a:bodyPr/>
                    <a:lstStyle/>
                    <a:p>
                      <a:r>
                        <a:rPr lang="en-US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78620">
                <a:tc>
                  <a:txBody>
                    <a:bodyPr/>
                    <a:lstStyle/>
                    <a:p>
                      <a:r>
                        <a:rPr lang="en-US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A087C4A-9BB1-074F-AC6F-C9881132098A}"/>
              </a:ext>
            </a:extLst>
          </p:cNvPr>
          <p:cNvCxnSpPr>
            <a:cxnSpLocks/>
          </p:cNvCxnSpPr>
          <p:nvPr/>
        </p:nvCxnSpPr>
        <p:spPr>
          <a:xfrm>
            <a:off x="5137813" y="411480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B33AAEF-34F7-C840-9A8F-1F67B925CE17}"/>
              </a:ext>
            </a:extLst>
          </p:cNvPr>
          <p:cNvCxnSpPr>
            <a:cxnSpLocks/>
          </p:cNvCxnSpPr>
          <p:nvPr/>
        </p:nvCxnSpPr>
        <p:spPr>
          <a:xfrm>
            <a:off x="6193183" y="411480"/>
            <a:ext cx="0" cy="139192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40EB11E0-0D92-674E-BFAF-BE7C71D1ABB8}"/>
              </a:ext>
            </a:extLst>
          </p:cNvPr>
          <p:cNvSpPr/>
          <p:nvPr/>
        </p:nvSpPr>
        <p:spPr>
          <a:xfrm>
            <a:off x="2565915" y="3859768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FLA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53F569-76B9-8241-93CF-F8418A4FE23B}"/>
              </a:ext>
            </a:extLst>
          </p:cNvPr>
          <p:cNvSpPr txBox="1"/>
          <p:nvPr/>
        </p:nvSpPr>
        <p:spPr>
          <a:xfrm>
            <a:off x="8969831" y="313878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F343056-5442-AB42-BCA1-B9C0FEDA9BE9}"/>
              </a:ext>
            </a:extLst>
          </p:cNvPr>
          <p:cNvCxnSpPr>
            <a:cxnSpLocks/>
          </p:cNvCxnSpPr>
          <p:nvPr/>
        </p:nvCxnSpPr>
        <p:spPr>
          <a:xfrm flipH="1">
            <a:off x="8752787" y="52251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010EEC2-68B5-E249-9FB1-97A26FE7A2F9}"/>
              </a:ext>
            </a:extLst>
          </p:cNvPr>
          <p:cNvCxnSpPr>
            <a:cxnSpLocks/>
          </p:cNvCxnSpPr>
          <p:nvPr/>
        </p:nvCxnSpPr>
        <p:spPr>
          <a:xfrm flipH="1">
            <a:off x="8755247" y="332636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94873BA3-88D8-1545-A122-9FBBCB17BC8C}"/>
              </a:ext>
            </a:extLst>
          </p:cNvPr>
          <p:cNvSpPr/>
          <p:nvPr/>
        </p:nvSpPr>
        <p:spPr>
          <a:xfrm>
            <a:off x="8935541" y="5039005"/>
            <a:ext cx="16669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 smtClean="0"/>
              <a:t>cytTM-SpoIVFB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821BF36-8789-D14D-9818-C936AE771345}"/>
              </a:ext>
            </a:extLst>
          </p:cNvPr>
          <p:cNvSpPr txBox="1"/>
          <p:nvPr/>
        </p:nvSpPr>
        <p:spPr>
          <a:xfrm>
            <a:off x="4240476" y="405655"/>
            <a:ext cx="7393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M30C</a:t>
            </a:r>
          </a:p>
          <a:p>
            <a:pPr algn="ctr"/>
            <a:r>
              <a:rPr lang="en-US" dirty="0"/>
              <a:t>C46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DA7CFE-1600-044E-B6E2-BDF723CD1257}"/>
              </a:ext>
            </a:extLst>
          </p:cNvPr>
          <p:cNvSpPr txBox="1"/>
          <p:nvPr/>
        </p:nvSpPr>
        <p:spPr>
          <a:xfrm>
            <a:off x="5295846" y="399829"/>
            <a:ext cx="7393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M30C</a:t>
            </a:r>
          </a:p>
          <a:p>
            <a:pPr algn="ctr"/>
            <a:r>
              <a:rPr lang="en-US" dirty="0"/>
              <a:t>L62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6A59EF-1874-5349-955A-B29A4390104C}"/>
              </a:ext>
            </a:extLst>
          </p:cNvPr>
          <p:cNvSpPr txBox="1"/>
          <p:nvPr/>
        </p:nvSpPr>
        <p:spPr>
          <a:xfrm>
            <a:off x="6303701" y="399829"/>
            <a:ext cx="7393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M30C</a:t>
            </a:r>
          </a:p>
          <a:p>
            <a:pPr algn="ctr"/>
            <a:r>
              <a:rPr lang="en-US" dirty="0"/>
              <a:t>V63C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E12EDBA-4F55-4548-BF79-E0799DA3CC1F}"/>
              </a:ext>
            </a:extLst>
          </p:cNvPr>
          <p:cNvCxnSpPr>
            <a:cxnSpLocks/>
          </p:cNvCxnSpPr>
          <p:nvPr/>
        </p:nvCxnSpPr>
        <p:spPr>
          <a:xfrm flipH="1">
            <a:off x="8752787" y="366181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887661D4-18AC-DF49-A253-AA9D0B202B7A}"/>
              </a:ext>
            </a:extLst>
          </p:cNvPr>
          <p:cNvSpPr/>
          <p:nvPr/>
        </p:nvSpPr>
        <p:spPr>
          <a:xfrm>
            <a:off x="8935541" y="3475697"/>
            <a:ext cx="166699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 </a:t>
            </a:r>
            <a:r>
              <a:rPr lang="en-US" dirty="0" err="1"/>
              <a:t>cytTM-SpoIVFB</a:t>
            </a:r>
            <a:endParaRPr lang="en-US" dirty="0"/>
          </a:p>
          <a:p>
            <a:r>
              <a:rPr lang="en-US" dirty="0"/>
              <a:t>dimer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4868B95-8FB1-854E-9BA4-6977937FF255}"/>
              </a:ext>
            </a:extLst>
          </p:cNvPr>
          <p:cNvSpPr/>
          <p:nvPr/>
        </p:nvSpPr>
        <p:spPr>
          <a:xfrm>
            <a:off x="2586185" y="4122028"/>
            <a:ext cx="7280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lot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2848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0D549805-C7B1-4F5E-B733-44778735A7E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C705805-6D96-49F7-B3B9-4592A064475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4589560-AD08-4944-BE98-762300BBB6D8}">
  <ds:schemaRefs>
    <ds:schemaRef ds:uri="http://schemas.microsoft.com/office/2006/metadata/properties"/>
    <ds:schemaRef ds:uri="0b01a07b-8d13-4cb5-9d22-64822278069e"/>
    <ds:schemaRef ds:uri="http://schemas.microsoft.com/office/2006/documentManagement/types"/>
    <ds:schemaRef ds:uri="http://purl.org/dc/terms/"/>
    <ds:schemaRef ds:uri="http://www.w3.org/XML/1998/namespace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198a9f0d-948e-4f5a-af70-f6d2f30972cd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92</Words>
  <Application>Microsoft Office PowerPoint</Application>
  <PresentationFormat>Widescreen</PresentationFormat>
  <Paragraphs>8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8</cp:revision>
  <dcterms:created xsi:type="dcterms:W3CDTF">2021-10-07T16:39:56Z</dcterms:created>
  <dcterms:modified xsi:type="dcterms:W3CDTF">2021-10-12T18:04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